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  <p:sldId id="259" r:id="rId5"/>
  </p:sldIdLst>
  <p:sldSz cx="12192000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3"/>
  </p:normalViewPr>
  <p:slideViewPr>
    <p:cSldViewPr snapToGrid="0" snapToObjects="1">
      <p:cViewPr>
        <p:scale>
          <a:sx n="97" d="100"/>
          <a:sy n="97" d="100"/>
        </p:scale>
        <p:origin x="116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945943"/>
            <a:ext cx="10363200" cy="626689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9454516"/>
            <a:ext cx="9144000" cy="434599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67376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82806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958369"/>
            <a:ext cx="2628900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958369"/>
            <a:ext cx="7734300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7995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59840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487671"/>
            <a:ext cx="10515600" cy="74877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2046282"/>
            <a:ext cx="10515600" cy="393764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98522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791843"/>
            <a:ext cx="5181600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791843"/>
            <a:ext cx="5181600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46156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58373"/>
            <a:ext cx="10515600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4412664"/>
            <a:ext cx="5157787" cy="216257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6575242"/>
            <a:ext cx="5157787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412664"/>
            <a:ext cx="5183188" cy="216257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6575242"/>
            <a:ext cx="5183188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24938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33060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0286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00044"/>
            <a:ext cx="3932237" cy="420015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591766"/>
            <a:ext cx="6172200" cy="12792138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400199"/>
            <a:ext cx="3932237" cy="1000453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28323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00044"/>
            <a:ext cx="3932237" cy="420015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591766"/>
            <a:ext cx="6172200" cy="12792138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400199"/>
            <a:ext cx="3932237" cy="1000453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24682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958373"/>
            <a:ext cx="10515600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791843"/>
            <a:ext cx="10515600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6683952"/>
            <a:ext cx="27432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127D43-D705-374C-A006-4F2800675037}" type="datetimeFigureOut">
              <a:rPr kumimoji="1" lang="zh-CN" altLang="en-US" smtClean="0"/>
              <a:t>2022/4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6683952"/>
            <a:ext cx="41148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6683952"/>
            <a:ext cx="27432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E7F38-806B-6F47-AFE7-E48E7A0818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15217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zhaoqinjian@xmu.edu.cn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6C2AB1D-CA76-3988-2A2C-7E20483724B1}"/>
              </a:ext>
            </a:extLst>
          </p:cNvPr>
          <p:cNvSpPr txBox="1"/>
          <p:nvPr/>
        </p:nvSpPr>
        <p:spPr>
          <a:xfrm>
            <a:off x="904998" y="668378"/>
            <a:ext cx="10382003" cy="62170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2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Information for</a:t>
            </a:r>
          </a:p>
          <a:p>
            <a:pPr algn="ctr"/>
            <a:endParaRPr lang="zh-CN" altLang="zh-CN" sz="16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ctr"/>
            <a:r>
              <a:rPr lang="en-US" altLang="zh-CN" sz="2000" b="1" kern="1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﻿</a:t>
            </a:r>
            <a:r>
              <a:rPr lang="en-US" altLang="zh-CN" sz="20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 Bacterially Expressed SARS-CoV-2 Receptor Binding Domain Fused With Cross-Reacting Material 197 A Domain Elicits High Level of Neutralizing Antibodies in Mice</a:t>
            </a:r>
            <a:endParaRPr lang="zh-CN" altLang="zh-CN" sz="16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zh-CN" sz="1600" kern="1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﻿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algn="ctr">
              <a:lnSpc>
                <a:spcPct val="150000"/>
              </a:lnSpc>
            </a:pP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﻿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qin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u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†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ngting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hen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†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zhi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Zhou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Jie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un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uqian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ifeng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ie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ualong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Xiong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uhe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Zhu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enhui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Xue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angtao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u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ngting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anying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Zhang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Zhibo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Kong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Hai Yu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Jun Zhang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Ying Gu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ingbing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Zheng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injian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Zhao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*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ingshao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Xia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Shaowei Li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,2*</a:t>
            </a:r>
          </a:p>
          <a:p>
            <a:pPr algn="ctr"/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 </a:t>
            </a:r>
            <a:endParaRPr lang="zh-CN" altLang="zh-CN" sz="14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en-US" altLang="zh-CN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﻿1State Key Laboratory of Molecular Vaccinology and Molecular Diagnostics, School of Life Sciences and School of Public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alth, Xiamen University, Xiamen, China, 2National Institute of Diagnostics and Vaccine Development in Infectious Diseases,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Xiamen University, Xiamen, China</a:t>
            </a:r>
          </a:p>
          <a:p>
            <a:pPr algn="just"/>
            <a:endParaRPr lang="en-US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﻿†These authors have contributed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qually to this work.</a:t>
            </a:r>
          </a:p>
          <a:p>
            <a:pPr algn="just"/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*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sponding author: Shaowei Li, </a:t>
            </a:r>
            <a:r>
              <a:rPr lang="en-US" altLang="zh-CN" sz="14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haowei@xmu.edu.cn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altLang="zh-CN" sz="14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injian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Zhao,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hlinkClick r:id="rId2"/>
              </a:rPr>
              <a:t>zhaoqinjian@xmu.edu.cn</a:t>
            </a:r>
            <a:endParaRPr lang="en-US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en-US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en-US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en-US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is file includes:  </a:t>
            </a:r>
          </a:p>
          <a:p>
            <a:pPr algn="just"/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</a:t>
            </a:r>
          </a:p>
          <a:p>
            <a:pPr algn="just"/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Table S1, S2 </a:t>
            </a:r>
          </a:p>
          <a:p>
            <a:pPr algn="just"/>
            <a:endParaRPr lang="en-US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zh-CN" altLang="zh-CN" sz="16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5780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BCCC2959-6641-89E2-CFD6-9DD46373455D}"/>
              </a:ext>
            </a:extLst>
          </p:cNvPr>
          <p:cNvSpPr txBox="1"/>
          <p:nvPr/>
        </p:nvSpPr>
        <p:spPr>
          <a:xfrm>
            <a:off x="312420" y="15985332"/>
            <a:ext cx="11597082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US" altLang="zh-CN" sz="1600" b="1" kern="1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﻿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low cytometric gating strategy for detecting T cell subsets after immunization. </a:t>
            </a:r>
            <a:endParaRPr lang="zh-CN" altLang="zh-CN" sz="16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plenocytes were collected from spleen of mice immunized with CRMA-RBD, RBD or RBD (Bac) with adjuvant and stimulated with SARS-CoV-2 RBD peptide pools. 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D4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 cells or CD8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 cells were gated from splenocytes.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B, C)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resentative plots for every experimental group, which were generated at the time point on 7 days after the third immunization. 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requencies of IFN-γ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D4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 cells, IL-2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D4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 cells among CD4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 cells sorted from the indicated upper gate in the right panel in 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 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requencies of IFN-γ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D8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 cells, IL-2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D8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 cells among CD8</a:t>
            </a:r>
            <a:r>
              <a:rPr lang="en-US" altLang="zh-CN" sz="16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 cells sorted from the indicated lower gate in the right panel in </a:t>
            </a:r>
            <a:r>
              <a:rPr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FSC-A, forward scatter area; SSC-A, side scatter area; FSC-H, forward scatter height; SSC-H, side scatter height.</a:t>
            </a:r>
            <a:endParaRPr lang="zh-CN" altLang="zh-CN" sz="16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3195D47A-27C4-FBE3-A1E8-4433A09324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6247" y="0"/>
            <a:ext cx="8842002" cy="15985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61782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id="{B6F17A15-8F39-951A-CD2D-1A5BB66935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806686"/>
              </p:ext>
            </p:extLst>
          </p:nvPr>
        </p:nvGraphicFramePr>
        <p:xfrm>
          <a:off x="948372" y="1228884"/>
          <a:ext cx="9178608" cy="2194560"/>
        </p:xfrm>
        <a:graphic>
          <a:graphicData uri="http://schemas.openxmlformats.org/drawingml/2006/table">
            <a:tbl>
              <a:tblPr firstRow="1" firstCol="1" bandRow="1"/>
              <a:tblGrid>
                <a:gridCol w="2333879">
                  <a:extLst>
                    <a:ext uri="{9D8B030D-6E8A-4147-A177-3AD203B41FA5}">
                      <a16:colId xmlns:a16="http://schemas.microsoft.com/office/drawing/2014/main" val="1984900945"/>
                    </a:ext>
                  </a:extLst>
                </a:gridCol>
                <a:gridCol w="6844729">
                  <a:extLst>
                    <a:ext uri="{9D8B030D-6E8A-4147-A177-3AD203B41FA5}">
                      <a16:colId xmlns:a16="http://schemas.microsoft.com/office/drawing/2014/main" val="3421403473"/>
                    </a:ext>
                  </a:extLst>
                </a:gridCol>
              </a:tblGrid>
              <a:tr h="170815">
                <a:tc>
                  <a:txBody>
                    <a:bodyPr/>
                    <a:lstStyle/>
                    <a:p>
                      <a:pPr algn="ctr"/>
                      <a:r>
                        <a:rPr lang="zh-CN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Primer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Sequence</a:t>
                      </a: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'</a:t>
                      </a:r>
                      <a:r>
                        <a:rPr lang="zh-CN" sz="1600" kern="0" dirty="0">
                          <a:solidFill>
                            <a:srgbClr val="000000"/>
                          </a:solidFill>
                          <a:effectLst/>
                          <a:latin typeface="DengXian" panose="02010600030101010101" pitchFamily="2" charset="-122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→</a:t>
                      </a: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')</a:t>
                      </a:r>
                      <a:endParaRPr lang="zh-CN" sz="1600" kern="100" dirty="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5233389"/>
                  </a:ext>
                </a:extLst>
              </a:tr>
              <a:tr h="17081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pTO-T7-CRMA-L-R</a:t>
                      </a:r>
                      <a:endParaRPr lang="zh-CN" sz="1600" kern="100" dirty="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GATCCACCGCCACCGCTGCCACCGCCACCGCTGCCACCGCCACCA</a:t>
                      </a:r>
                      <a:endParaRPr lang="zh-CN" sz="1600" kern="100" dirty="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CGATTTCCTGCACA</a:t>
                      </a:r>
                      <a:endParaRPr lang="zh-CN" sz="1600" kern="100" dirty="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3975710"/>
                  </a:ext>
                </a:extLst>
              </a:tr>
              <a:tr h="170815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pTO-T7-VF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GAGATCCGGCTGCTAACAA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5280407"/>
                  </a:ext>
                </a:extLst>
              </a:tr>
              <a:tr h="170815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pTO-T7-VR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CATATGTATATCTCCTTCTT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157539"/>
                  </a:ext>
                </a:extLst>
              </a:tr>
              <a:tr h="170815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CRMA-L-RBD-F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CAGCGGTGGCGGTGGATCCAGAGTCCAACCAACAGAATC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4830156"/>
                  </a:ext>
                </a:extLst>
              </a:tr>
              <a:tr h="170815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CRMA-L-RBD-R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TGTTAGCAGCCGGATCTCAGAAATTGACACATTTGTTTT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7193983"/>
                  </a:ext>
                </a:extLst>
              </a:tr>
              <a:tr h="170815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RBD-F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AAGGAGATATACATATGAGAGTCCAACCAACAGAATC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505834"/>
                  </a:ext>
                </a:extLst>
              </a:tr>
              <a:tr h="170815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RBD-R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TGTTAGCAGCCGGATCTCAGAAATTGACACATTTGTTTT</a:t>
                      </a:r>
                      <a:endParaRPr lang="zh-CN" sz="1600" kern="100" dirty="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7908882"/>
                  </a:ext>
                </a:extLst>
              </a:tr>
            </a:tbl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id="{A80DAD6D-B10B-E84A-05D1-E7C91F89CC4E}"/>
              </a:ext>
            </a:extLst>
          </p:cNvPr>
          <p:cNvSpPr txBox="1"/>
          <p:nvPr/>
        </p:nvSpPr>
        <p:spPr>
          <a:xfrm>
            <a:off x="948372" y="608092"/>
            <a:ext cx="61036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ble S1. Primer sequences used in this study.</a:t>
            </a:r>
            <a:endParaRPr lang="zh-CN" altLang="zh-CN" sz="1800" b="1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53948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5485756-BFC7-3B66-1111-6E6712EBE0B5}"/>
              </a:ext>
            </a:extLst>
          </p:cNvPr>
          <p:cNvSpPr txBox="1"/>
          <p:nvPr/>
        </p:nvSpPr>
        <p:spPr>
          <a:xfrm>
            <a:off x="948372" y="608092"/>
            <a:ext cx="76012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ble S2. SARS-CoV-2 RBD overlapping peptides used in this study.</a:t>
            </a:r>
            <a:endParaRPr lang="zh-CN" altLang="zh-CN" sz="1800" b="1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D31E5A10-7630-9D27-230D-3BFE228643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8760356"/>
              </p:ext>
            </p:extLst>
          </p:nvPr>
        </p:nvGraphicFramePr>
        <p:xfrm>
          <a:off x="1196952" y="1139346"/>
          <a:ext cx="3936751" cy="14386560"/>
        </p:xfrm>
        <a:graphic>
          <a:graphicData uri="http://schemas.openxmlformats.org/drawingml/2006/table">
            <a:tbl>
              <a:tblPr firstRow="1" firstCol="1" bandRow="1"/>
              <a:tblGrid>
                <a:gridCol w="1190473">
                  <a:extLst>
                    <a:ext uri="{9D8B030D-6E8A-4147-A177-3AD203B41FA5}">
                      <a16:colId xmlns:a16="http://schemas.microsoft.com/office/drawing/2014/main" val="1520690833"/>
                    </a:ext>
                  </a:extLst>
                </a:gridCol>
                <a:gridCol w="2746278">
                  <a:extLst>
                    <a:ext uri="{9D8B030D-6E8A-4147-A177-3AD203B41FA5}">
                      <a16:colId xmlns:a16="http://schemas.microsoft.com/office/drawing/2014/main" val="3694417952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/>
                      <a:r>
                        <a:rPr lang="zh-CN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Sequence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663579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VEKGIYQTSNFRVQP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9822714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IYQTSNFRVQPTESI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6936495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SNFRVQPTESIVRFP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7673490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VQPTESIVRFPNITN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6389701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ESIVRFPNITNLCPF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0008621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RFPNITNLCPFGEVF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2182644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ITNLCPFGEVFNATR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350475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CPFGEVFNATRFASV</a:t>
                      </a:r>
                      <a:endParaRPr lang="zh-CN" sz="1600" kern="100" dirty="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6091546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9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EVFNATRFASVYAWN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8931196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0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ATRFASVYAWNRKRI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6778693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1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ASVYAWNRKRISNCV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3928445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2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AWNRKRISNCVADYS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8290759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3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KRISNCVADYSVLYN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3106642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4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CVADYSVLYNSASF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31062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5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DYSVLYNSASFSTFK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499710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6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LYNSASFSTFKCYGV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0793983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7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ASFSTFKCYGVSPTK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5812974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8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FKCYGVSPTKLNDL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7061951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9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YGVSPTKLNDLCFTN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3481753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0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PTKLNDLCFTNVYAD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3404124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1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DLCFTNVYADSFVI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5477329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2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FTNVYADSFVIRGDE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8389439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3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YADSFVIRGDEVRQI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8412834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4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FVIRGDEVRQIAPGQ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7093173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5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DEVRQIAPGQTGKI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078006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6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RQIAPGQTGKIADYN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0143153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7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PGQTGKIADYNYKLP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0608878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8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KIADYNYKLPDDFT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5247874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9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DYNYKLPDDFTGCVI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297612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0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KLPDDFTGCVIAWNS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888648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1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DFTGCVIAWNSNNLD</a:t>
                      </a:r>
                      <a:endParaRPr lang="zh-CN" sz="1600" kern="100" dirty="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9637005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2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CVIAWNSNNLDSKVG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137766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3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WNSNNLDSKVGGNYN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1453590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4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LDSKVGGNYNYLYR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8997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5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KVGGNYNYLYRLFRK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406113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6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YNYLYRLFRKSNLK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6971372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7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LYRLFRKSNLKPFER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874236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8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FRKSNLKPFERDIST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8854017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9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LKPFERDISTEIYQ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1001793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0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FERDISTEIYQAGST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4780049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1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ISTEIYQAGSTPCNG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517751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2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IYQAGSTPCNGVEGF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382995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3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STPCNGVEGFNCYF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2610817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4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CNGVEGFNCYFPLQS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2579859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5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EGFNCYFPLQSYGFQ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3218068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6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CYFPLQSYGFQPTNG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5702302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7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LQSYGFQPTNGVGYQ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8964507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8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FQPTNGVGYQPYRV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1849720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9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NGVGYQPYRVVVLS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4321552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0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YQPYRVVVLSFELL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6421944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1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YRVVVLSFELLHAPA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1430942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2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VLSFELLHAPATVCG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9260733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3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ELLHAPATVCGPKKS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2152300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4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APATVCGPKKSTNLV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7325952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5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VCGPKKSTNLVKNKC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2355500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6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KKSTNLVKNKCVNFN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2294811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7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LVKNKCVNFNFNGL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7170638"/>
                  </a:ext>
                </a:extLst>
              </a:tr>
              <a:tr h="187960">
                <a:tc>
                  <a:txBody>
                    <a:bodyPr/>
                    <a:lstStyle/>
                    <a:p>
                      <a:pPr algn="ctr"/>
                      <a:r>
                        <a:rPr lang="en-US" sz="16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8</a:t>
                      </a:r>
                      <a:endParaRPr lang="zh-CN" sz="1600" kern="10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600" kern="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KCVNFNFNGLT</a:t>
                      </a:r>
                      <a:endParaRPr lang="zh-CN" sz="1600" kern="100" dirty="0">
                        <a:effectLst/>
                        <a:latin typeface="DengXian" panose="02010600030101010101" pitchFamily="2" charset="-122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5331797"/>
                  </a:ext>
                </a:extLst>
              </a:tr>
            </a:tbl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B8D199D0-FFF3-3A9C-A22F-18E99CF2EC75}"/>
              </a:ext>
            </a:extLst>
          </p:cNvPr>
          <p:cNvSpPr txBox="1"/>
          <p:nvPr/>
        </p:nvSpPr>
        <p:spPr>
          <a:xfrm>
            <a:off x="1017111" y="15687828"/>
            <a:ext cx="1015777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is pool includes 58 peptides derived from a peptide scan (15 aa length, 11 aa overlap) through the entire SARS-CoV-2 RBD (aa 308-547) for T cell assays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2249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563</Words>
  <Application>Microsoft Macintosh PowerPoint</Application>
  <PresentationFormat>自定义</PresentationFormat>
  <Paragraphs>157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1" baseType="lpstr">
      <vt:lpstr>DengXian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Microsoft Office User</cp:lastModifiedBy>
  <cp:revision>6</cp:revision>
  <dcterms:created xsi:type="dcterms:W3CDTF">2022-04-15T15:21:35Z</dcterms:created>
  <dcterms:modified xsi:type="dcterms:W3CDTF">2022-04-15T16:09:54Z</dcterms:modified>
</cp:coreProperties>
</file>